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69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nnemarie Bardelmeijer" userId="519a7264eed128a7" providerId="LiveId" clId="{0B5999C2-8690-445E-90A5-9B1C61AB2381}"/>
    <pc:docChg chg="custSel addSld delSld modSld">
      <pc:chgData name="Annemarie Bardelmeijer" userId="519a7264eed128a7" providerId="LiveId" clId="{0B5999C2-8690-445E-90A5-9B1C61AB2381}" dt="2024-10-24T06:44:17.195" v="70" actId="2696"/>
      <pc:docMkLst>
        <pc:docMk/>
      </pc:docMkLst>
      <pc:sldChg chg="addSp modSp mod">
        <pc:chgData name="Annemarie Bardelmeijer" userId="519a7264eed128a7" providerId="LiveId" clId="{0B5999C2-8690-445E-90A5-9B1C61AB2381}" dt="2024-10-24T06:43:34.238" v="41" actId="1076"/>
        <pc:sldMkLst>
          <pc:docMk/>
          <pc:sldMk cId="3623253178" sldId="256"/>
        </pc:sldMkLst>
        <pc:spChg chg="mod">
          <ac:chgData name="Annemarie Bardelmeijer" userId="519a7264eed128a7" providerId="LiveId" clId="{0B5999C2-8690-445E-90A5-9B1C61AB2381}" dt="2024-10-24T06:43:16.543" v="35" actId="1076"/>
          <ac:spMkLst>
            <pc:docMk/>
            <pc:sldMk cId="3623253178" sldId="256"/>
            <ac:spMk id="6" creationId="{E01243E9-FB04-A7CB-A3F3-9700A55164D6}"/>
          </ac:spMkLst>
        </pc:spChg>
        <pc:picChg chg="mod">
          <ac:chgData name="Annemarie Bardelmeijer" userId="519a7264eed128a7" providerId="LiveId" clId="{0B5999C2-8690-445E-90A5-9B1C61AB2381}" dt="2024-10-24T06:43:19.473" v="36" actId="1076"/>
          <ac:picMkLst>
            <pc:docMk/>
            <pc:sldMk cId="3623253178" sldId="256"/>
            <ac:picMk id="5" creationId="{7664D928-0598-2656-195C-00560C1E6AA8}"/>
          </ac:picMkLst>
        </pc:picChg>
        <pc:picChg chg="add mod">
          <ac:chgData name="Annemarie Bardelmeijer" userId="519a7264eed128a7" providerId="LiveId" clId="{0B5999C2-8690-445E-90A5-9B1C61AB2381}" dt="2024-10-24T06:43:34.238" v="41" actId="1076"/>
          <ac:picMkLst>
            <pc:docMk/>
            <pc:sldMk cId="3623253178" sldId="256"/>
            <ac:picMk id="8" creationId="{B709B9B3-1D45-1113-8061-477250BA2861}"/>
          </ac:picMkLst>
        </pc:picChg>
      </pc:sldChg>
      <pc:sldChg chg="addSp modSp mod">
        <pc:chgData name="Annemarie Bardelmeijer" userId="519a7264eed128a7" providerId="LiveId" clId="{0B5999C2-8690-445E-90A5-9B1C61AB2381}" dt="2024-10-24T06:44:12.847" v="69" actId="1076"/>
        <pc:sldMkLst>
          <pc:docMk/>
          <pc:sldMk cId="4117907239" sldId="257"/>
        </pc:sldMkLst>
        <pc:spChg chg="mod">
          <ac:chgData name="Annemarie Bardelmeijer" userId="519a7264eed128a7" providerId="LiveId" clId="{0B5999C2-8690-445E-90A5-9B1C61AB2381}" dt="2024-10-24T06:43:59.748" v="65" actId="20577"/>
          <ac:spMkLst>
            <pc:docMk/>
            <pc:sldMk cId="4117907239" sldId="257"/>
            <ac:spMk id="6" creationId="{2F825A3B-B846-830F-BDB7-A3DACCB5C645}"/>
          </ac:spMkLst>
        </pc:spChg>
        <pc:picChg chg="add mod">
          <ac:chgData name="Annemarie Bardelmeijer" userId="519a7264eed128a7" providerId="LiveId" clId="{0B5999C2-8690-445E-90A5-9B1C61AB2381}" dt="2024-10-24T06:44:12.847" v="69" actId="1076"/>
          <ac:picMkLst>
            <pc:docMk/>
            <pc:sldMk cId="4117907239" sldId="257"/>
            <ac:picMk id="7" creationId="{C4C28536-FD78-D7BA-049F-C8CD19F15C06}"/>
          </ac:picMkLst>
        </pc:picChg>
      </pc:sldChg>
      <pc:sldChg chg="addSp modSp del mod">
        <pc:chgData name="Annemarie Bardelmeijer" userId="519a7264eed128a7" providerId="LiveId" clId="{0B5999C2-8690-445E-90A5-9B1C61AB2381}" dt="2024-10-24T06:44:17.195" v="70" actId="2696"/>
        <pc:sldMkLst>
          <pc:docMk/>
          <pc:sldMk cId="2387628957" sldId="258"/>
        </pc:sldMkLst>
        <pc:picChg chg="add mod">
          <ac:chgData name="Annemarie Bardelmeijer" userId="519a7264eed128a7" providerId="LiveId" clId="{0B5999C2-8690-445E-90A5-9B1C61AB2381}" dt="2024-10-24T06:41:38.057" v="2" actId="14100"/>
          <ac:picMkLst>
            <pc:docMk/>
            <pc:sldMk cId="2387628957" sldId="258"/>
            <ac:picMk id="6" creationId="{E684A4E6-FE54-A010-B16D-C0D8E3FE654E}"/>
          </ac:picMkLst>
        </pc:picChg>
      </pc:sldChg>
      <pc:sldChg chg="addSp delSp modSp new del mod">
        <pc:chgData name="Annemarie Bardelmeijer" userId="519a7264eed128a7" providerId="LiveId" clId="{0B5999C2-8690-445E-90A5-9B1C61AB2381}" dt="2024-10-24T06:43:44.085" v="42" actId="2696"/>
        <pc:sldMkLst>
          <pc:docMk/>
          <pc:sldMk cId="65348945" sldId="259"/>
        </pc:sldMkLst>
        <pc:spChg chg="del">
          <ac:chgData name="Annemarie Bardelmeijer" userId="519a7264eed128a7" providerId="LiveId" clId="{0B5999C2-8690-445E-90A5-9B1C61AB2381}" dt="2024-10-24T06:42:06.793" v="16" actId="478"/>
          <ac:spMkLst>
            <pc:docMk/>
            <pc:sldMk cId="65348945" sldId="259"/>
            <ac:spMk id="2" creationId="{9ADA410B-7389-09C1-1FBE-48376B756ED8}"/>
          </ac:spMkLst>
        </pc:spChg>
        <pc:spChg chg="del">
          <ac:chgData name="Annemarie Bardelmeijer" userId="519a7264eed128a7" providerId="LiveId" clId="{0B5999C2-8690-445E-90A5-9B1C61AB2381}" dt="2024-10-24T06:42:07.725" v="17" actId="478"/>
          <ac:spMkLst>
            <pc:docMk/>
            <pc:sldMk cId="65348945" sldId="259"/>
            <ac:spMk id="3" creationId="{BD8DE178-1BEB-DAD2-E252-9DBF6E14C698}"/>
          </ac:spMkLst>
        </pc:spChg>
        <pc:spChg chg="add mod">
          <ac:chgData name="Annemarie Bardelmeijer" userId="519a7264eed128a7" providerId="LiveId" clId="{0B5999C2-8690-445E-90A5-9B1C61AB2381}" dt="2024-10-24T06:42:08.743" v="18"/>
          <ac:spMkLst>
            <pc:docMk/>
            <pc:sldMk cId="65348945" sldId="259"/>
            <ac:spMk id="4" creationId="{B1C649CC-C5C2-001A-1242-BD9D51B728CC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BD47D64-979F-4EF1-493C-5505CC234C2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Ondertitel 2">
            <a:extLst>
              <a:ext uri="{FF2B5EF4-FFF2-40B4-BE49-F238E27FC236}">
                <a16:creationId xmlns:a16="http://schemas.microsoft.com/office/drawing/2014/main" id="{62979CDD-D738-4159-2A8A-B8B79453299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Klikken om de ondertitelstijl van het model te bewerken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79AB55BB-BC53-B71D-5534-21975C36C0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C30AAF-BD32-4B81-A063-98169BA64BE2}" type="datetimeFigureOut">
              <a:rPr lang="nl-NL" smtClean="0"/>
              <a:t>24-10-2024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9E766ACA-97AB-A3E9-08A7-F7850D37F1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00BE723D-30F0-5043-D130-012CD3F96E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E44699-BD92-42B4-90B1-DFF5D87FC6F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5963163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2139EB8-D83D-6E4F-56B6-DDCC72905E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3904791C-D99F-B431-E133-179A98D4E3C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4D6C479B-15E3-F0F2-4121-05260101EA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C30AAF-BD32-4B81-A063-98169BA64BE2}" type="datetimeFigureOut">
              <a:rPr lang="nl-NL" smtClean="0"/>
              <a:t>24-10-2024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BAF01372-EA4A-9E06-6C1C-317A8F9CFA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21C85229-0972-1928-82E5-1AD2D8DC58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E44699-BD92-42B4-90B1-DFF5D87FC6F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4159439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>
            <a:extLst>
              <a:ext uri="{FF2B5EF4-FFF2-40B4-BE49-F238E27FC236}">
                <a16:creationId xmlns:a16="http://schemas.microsoft.com/office/drawing/2014/main" id="{931949ED-85C9-8228-DDD7-5E7DF2AA043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B9045411-5439-75DA-E210-D616DE0D7AC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D3854EED-A334-0295-3DF2-B172E63950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C30AAF-BD32-4B81-A063-98169BA64BE2}" type="datetimeFigureOut">
              <a:rPr lang="nl-NL" smtClean="0"/>
              <a:t>24-10-2024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3F850972-D198-4E31-20C5-60A1558F88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AAD06338-4DC1-4986-C64C-61746B5B9B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E44699-BD92-42B4-90B1-DFF5D87FC6F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8247772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E840C2B-109D-EA8D-9B53-C97F7948AD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1CD1F893-0F64-9A6E-C1B8-E968279072E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52EE3C1D-12C8-3781-88F8-6E978CB539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C30AAF-BD32-4B81-A063-98169BA64BE2}" type="datetimeFigureOut">
              <a:rPr lang="nl-NL" smtClean="0"/>
              <a:t>24-10-2024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E466691C-3BBB-F46E-4D58-C0E3883826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9784C37E-69C7-1A29-0B76-E1F03613B2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E44699-BD92-42B4-90B1-DFF5D87FC6F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7025431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B1D845B-79E6-946D-3A3D-623EE0FA32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6FD56C82-E50A-B39F-FE04-2CAC687917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42920D61-97CD-BFFF-694C-8D00B3D69C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C30AAF-BD32-4B81-A063-98169BA64BE2}" type="datetimeFigureOut">
              <a:rPr lang="nl-NL" smtClean="0"/>
              <a:t>24-10-2024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CE352BF4-330E-E823-F41B-16C77AD19A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24599AF5-625E-1655-D693-5F586D91DC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E44699-BD92-42B4-90B1-DFF5D87FC6F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9299413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422DA99-EADA-91D2-75E7-19D76C795D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F3B2E8AA-DC07-ED8E-CDDA-CD3DEB2DADA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4EA683A1-9BC1-DAE4-B6E6-23505C7294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4352622C-F013-FC57-ED8F-1B6F9935C7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C30AAF-BD32-4B81-A063-98169BA64BE2}" type="datetimeFigureOut">
              <a:rPr lang="nl-NL" smtClean="0"/>
              <a:t>24-10-2024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FBB0F4B0-BA64-E1C2-0B0D-4B35EBF6B0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EF2C5EA0-1FAD-E973-A06E-CBD63DF206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E44699-BD92-42B4-90B1-DFF5D87FC6F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8138292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E110383-1D1A-ED3C-0EE7-D9B32508A3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2C7FF438-44EB-B744-C658-BAF8E93C17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9723DE3B-4F06-84B1-366B-7AD186D6CEC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tekst 4">
            <a:extLst>
              <a:ext uri="{FF2B5EF4-FFF2-40B4-BE49-F238E27FC236}">
                <a16:creationId xmlns:a16="http://schemas.microsoft.com/office/drawing/2014/main" id="{519DF95F-F723-A953-C333-6A736F1C12F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6" name="Tijdelijke aanduiding voor inhoud 5">
            <a:extLst>
              <a:ext uri="{FF2B5EF4-FFF2-40B4-BE49-F238E27FC236}">
                <a16:creationId xmlns:a16="http://schemas.microsoft.com/office/drawing/2014/main" id="{4B5B0CB2-FBF6-8C03-B74E-648EE1A1771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7" name="Tijdelijke aanduiding voor datum 6">
            <a:extLst>
              <a:ext uri="{FF2B5EF4-FFF2-40B4-BE49-F238E27FC236}">
                <a16:creationId xmlns:a16="http://schemas.microsoft.com/office/drawing/2014/main" id="{89725092-4C2D-8208-185D-4912DD6753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C30AAF-BD32-4B81-A063-98169BA64BE2}" type="datetimeFigureOut">
              <a:rPr lang="nl-NL" smtClean="0"/>
              <a:t>24-10-2024</a:t>
            </a:fld>
            <a:endParaRPr lang="nl-NL"/>
          </a:p>
        </p:txBody>
      </p:sp>
      <p:sp>
        <p:nvSpPr>
          <p:cNvPr id="8" name="Tijdelijke aanduiding voor voettekst 7">
            <a:extLst>
              <a:ext uri="{FF2B5EF4-FFF2-40B4-BE49-F238E27FC236}">
                <a16:creationId xmlns:a16="http://schemas.microsoft.com/office/drawing/2014/main" id="{6B400834-EE29-B000-815F-F4BD7C78FE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>
            <a:extLst>
              <a:ext uri="{FF2B5EF4-FFF2-40B4-BE49-F238E27FC236}">
                <a16:creationId xmlns:a16="http://schemas.microsoft.com/office/drawing/2014/main" id="{E27DC8BA-65B1-EA9E-1988-0B52755107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E44699-BD92-42B4-90B1-DFF5D87FC6F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8902127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94968F9-D294-C747-A82B-6B2E4C77E6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datum 2">
            <a:extLst>
              <a:ext uri="{FF2B5EF4-FFF2-40B4-BE49-F238E27FC236}">
                <a16:creationId xmlns:a16="http://schemas.microsoft.com/office/drawing/2014/main" id="{85F00280-B494-D07C-2792-5EA8357F89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C30AAF-BD32-4B81-A063-98169BA64BE2}" type="datetimeFigureOut">
              <a:rPr lang="nl-NL" smtClean="0"/>
              <a:t>24-10-2024</a:t>
            </a:fld>
            <a:endParaRPr lang="nl-NL"/>
          </a:p>
        </p:txBody>
      </p:sp>
      <p:sp>
        <p:nvSpPr>
          <p:cNvPr id="4" name="Tijdelijke aanduiding voor voettekst 3">
            <a:extLst>
              <a:ext uri="{FF2B5EF4-FFF2-40B4-BE49-F238E27FC236}">
                <a16:creationId xmlns:a16="http://schemas.microsoft.com/office/drawing/2014/main" id="{F6FDBD5F-71C6-B303-17BD-0FB64633A2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>
            <a:extLst>
              <a:ext uri="{FF2B5EF4-FFF2-40B4-BE49-F238E27FC236}">
                <a16:creationId xmlns:a16="http://schemas.microsoft.com/office/drawing/2014/main" id="{800580F9-0182-1C5B-1B9F-BDE9BCE500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E44699-BD92-42B4-90B1-DFF5D87FC6F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2347559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>
            <a:extLst>
              <a:ext uri="{FF2B5EF4-FFF2-40B4-BE49-F238E27FC236}">
                <a16:creationId xmlns:a16="http://schemas.microsoft.com/office/drawing/2014/main" id="{BECC4CE9-1FEA-6DEB-3A3C-CBBCE28C86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C30AAF-BD32-4B81-A063-98169BA64BE2}" type="datetimeFigureOut">
              <a:rPr lang="nl-NL" smtClean="0"/>
              <a:t>24-10-2024</a:t>
            </a:fld>
            <a:endParaRPr lang="nl-NL"/>
          </a:p>
        </p:txBody>
      </p:sp>
      <p:sp>
        <p:nvSpPr>
          <p:cNvPr id="3" name="Tijdelijke aanduiding voor voettekst 2">
            <a:extLst>
              <a:ext uri="{FF2B5EF4-FFF2-40B4-BE49-F238E27FC236}">
                <a16:creationId xmlns:a16="http://schemas.microsoft.com/office/drawing/2014/main" id="{CA9CA910-8279-2939-B015-4C0724D8D9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>
            <a:extLst>
              <a:ext uri="{FF2B5EF4-FFF2-40B4-BE49-F238E27FC236}">
                <a16:creationId xmlns:a16="http://schemas.microsoft.com/office/drawing/2014/main" id="{8F8710D8-F48E-8586-3F33-052529EA8E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E44699-BD92-42B4-90B1-DFF5D87FC6F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8325358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F43E3C1-55B0-07CA-8787-3BF4EAB0A5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1DD90673-F0BE-E824-C127-130F249E429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81C7F1EC-4AE1-6DC3-1861-6C738EC72E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08199EEE-FBC5-D42A-89A4-76F52FD962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C30AAF-BD32-4B81-A063-98169BA64BE2}" type="datetimeFigureOut">
              <a:rPr lang="nl-NL" smtClean="0"/>
              <a:t>24-10-2024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490C61A4-5DB1-4EA2-BB0C-3850441EE0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561A6653-0DDF-2484-445B-B556765DF5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E44699-BD92-42B4-90B1-DFF5D87FC6F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2334048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3515C41-658C-B6CF-DAF1-7949599207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afbeelding 2">
            <a:extLst>
              <a:ext uri="{FF2B5EF4-FFF2-40B4-BE49-F238E27FC236}">
                <a16:creationId xmlns:a16="http://schemas.microsoft.com/office/drawing/2014/main" id="{C293D9EE-5947-880D-C2C8-3F7798EADAF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9B5F960E-F02B-A005-A19D-28343EB2657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8496016C-3C81-3E02-868B-03E1374806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C30AAF-BD32-4B81-A063-98169BA64BE2}" type="datetimeFigureOut">
              <a:rPr lang="nl-NL" smtClean="0"/>
              <a:t>24-10-2024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D4C17D85-D2C9-AC9B-B283-56C0C1BC5B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01E29908-C465-85CB-BCD7-93BAFB3866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E44699-BD92-42B4-90B1-DFF5D87FC6F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5885270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>
            <a:extLst>
              <a:ext uri="{FF2B5EF4-FFF2-40B4-BE49-F238E27FC236}">
                <a16:creationId xmlns:a16="http://schemas.microsoft.com/office/drawing/2014/main" id="{F0EB070B-0163-DCBE-6D3B-B4613639BE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DD63D993-07AF-AA3D-5ADB-3D22305B37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9D30F6CA-C52A-289E-DAB0-8199ED24EA7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C30AAF-BD32-4B81-A063-98169BA64BE2}" type="datetimeFigureOut">
              <a:rPr lang="nl-NL" smtClean="0"/>
              <a:t>24-10-2024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2118F724-5D02-C792-7F6B-523826574C7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B539118F-D238-9FB6-D509-6604C4CD9B5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E44699-BD92-42B4-90B1-DFF5D87FC6FC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7647480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Afbeelding 4">
            <a:extLst>
              <a:ext uri="{FF2B5EF4-FFF2-40B4-BE49-F238E27FC236}">
                <a16:creationId xmlns:a16="http://schemas.microsoft.com/office/drawing/2014/main" id="{7664D928-0598-2656-195C-00560C1E6AA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0259" y="1488140"/>
            <a:ext cx="5145741" cy="5145741"/>
          </a:xfrm>
          <a:prstGeom prst="rect">
            <a:avLst/>
          </a:prstGeom>
        </p:spPr>
      </p:pic>
      <p:sp>
        <p:nvSpPr>
          <p:cNvPr id="6" name="Tekstvak 5">
            <a:extLst>
              <a:ext uri="{FF2B5EF4-FFF2-40B4-BE49-F238E27FC236}">
                <a16:creationId xmlns:a16="http://schemas.microsoft.com/office/drawing/2014/main" id="{E01243E9-FB04-A7CB-A3F3-9700A55164D6}"/>
              </a:ext>
            </a:extLst>
          </p:cNvPr>
          <p:cNvSpPr txBox="1"/>
          <p:nvPr/>
        </p:nvSpPr>
        <p:spPr>
          <a:xfrm>
            <a:off x="304800" y="107576"/>
            <a:ext cx="2151529" cy="12008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n-GB" sz="16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ppendix 1. Advertisement online – English and Dutch</a:t>
            </a:r>
            <a:endParaRPr lang="nl-NL" sz="1600" kern="1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Afbeelding 7">
            <a:extLst>
              <a:ext uri="{FF2B5EF4-FFF2-40B4-BE49-F238E27FC236}">
                <a16:creationId xmlns:a16="http://schemas.microsoft.com/office/drawing/2014/main" id="{B709B9B3-1D45-1113-8061-477250BA286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2471" y="2070418"/>
            <a:ext cx="5789529" cy="42496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232531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Afbeelding 4">
            <a:extLst>
              <a:ext uri="{FF2B5EF4-FFF2-40B4-BE49-F238E27FC236}">
                <a16:creationId xmlns:a16="http://schemas.microsoft.com/office/drawing/2014/main" id="{B362226E-B27A-D621-F17D-4E24519824C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71849" y="0"/>
            <a:ext cx="4848301" cy="6858000"/>
          </a:xfrm>
          <a:prstGeom prst="rect">
            <a:avLst/>
          </a:prstGeom>
        </p:spPr>
      </p:pic>
      <p:sp>
        <p:nvSpPr>
          <p:cNvPr id="6" name="Tekstvak 5">
            <a:extLst>
              <a:ext uri="{FF2B5EF4-FFF2-40B4-BE49-F238E27FC236}">
                <a16:creationId xmlns:a16="http://schemas.microsoft.com/office/drawing/2014/main" id="{2F825A3B-B846-830F-BDB7-A3DACCB5C645}"/>
              </a:ext>
            </a:extLst>
          </p:cNvPr>
          <p:cNvSpPr txBox="1"/>
          <p:nvPr/>
        </p:nvSpPr>
        <p:spPr>
          <a:xfrm>
            <a:off x="484094" y="537882"/>
            <a:ext cx="274320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ppendix 1. Advertisement flyer and information screen</a:t>
            </a:r>
            <a:r>
              <a:rPr lang="nl-NL" sz="18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r>
              <a:rPr lang="nl-NL" sz="18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nl-NL" sz="1800" kern="1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nl-NL" dirty="0"/>
          </a:p>
        </p:txBody>
      </p:sp>
      <p:pic>
        <p:nvPicPr>
          <p:cNvPr id="7" name="Afbeelding 6">
            <a:extLst>
              <a:ext uri="{FF2B5EF4-FFF2-40B4-BE49-F238E27FC236}">
                <a16:creationId xmlns:a16="http://schemas.microsoft.com/office/drawing/2014/main" id="{C4C28536-FD78-D7BA-049F-C8CD19F15C0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84024" y="2196918"/>
            <a:ext cx="3307976" cy="27247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17907239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7</Words>
  <Application>Microsoft Office PowerPoint</Application>
  <PresentationFormat>Breedbeeld</PresentationFormat>
  <Paragraphs>2</Paragraphs>
  <Slides>2</Slides>
  <Notes>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3</vt:i4>
      </vt:variant>
      <vt:variant>
        <vt:lpstr>Thema</vt:lpstr>
      </vt:variant>
      <vt:variant>
        <vt:i4>1</vt:i4>
      </vt:variant>
      <vt:variant>
        <vt:lpstr>Diatitel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Kantoorthema</vt:lpstr>
      <vt:lpstr>PowerPoint-presentatie</vt:lpstr>
      <vt:lpstr>PowerPoint-presentatie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nnemarie Bardelmeijer</dc:creator>
  <cp:lastModifiedBy>Annemarie Bardelmeijer</cp:lastModifiedBy>
  <cp:revision>1</cp:revision>
  <dcterms:created xsi:type="dcterms:W3CDTF">2024-10-24T06:39:21Z</dcterms:created>
  <dcterms:modified xsi:type="dcterms:W3CDTF">2024-10-24T06:44:19Z</dcterms:modified>
</cp:coreProperties>
</file>